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jan" initials="M" lastIdx="3" clrIdx="0">
    <p:extLst>
      <p:ext uri="{19B8F6BF-5375-455C-9EA6-DF929625EA0E}">
        <p15:presenceInfo xmlns:p15="http://schemas.microsoft.com/office/powerpoint/2012/main" userId="suj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0867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185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86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384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500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615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558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567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170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252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841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977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03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2E735-E80A-4491-88C3-5E1E5112E39F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16A11-27DA-4F0D-B3C9-7A0B3DEB82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564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0" y="1367101"/>
            <a:ext cx="7223760" cy="2039908"/>
          </a:xfrm>
          <a:prstGeom prst="rect">
            <a:avLst/>
          </a:prstGeom>
        </p:spPr>
      </p:pic>
      <p:sp>
        <p:nvSpPr>
          <p:cNvPr id="5" name="TextBox 22"/>
          <p:cNvSpPr txBox="1"/>
          <p:nvPr/>
        </p:nvSpPr>
        <p:spPr>
          <a:xfrm>
            <a:off x="603125" y="3450992"/>
            <a:ext cx="73826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indent="-457200">
              <a:spcBef>
                <a:spcPts val="0"/>
              </a:spcBef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plementary Figure S1.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chematic representation of developing F</a:t>
            </a:r>
            <a:r>
              <a:rPr lang="en-US" sz="10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:7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ecombinant inbred lines (RILs) from R31 and Z0726-9 populations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1139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</TotalTime>
  <Words>2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ena</dc:creator>
  <cp:lastModifiedBy>Roy, Jayanta</cp:lastModifiedBy>
  <cp:revision>19</cp:revision>
  <dcterms:created xsi:type="dcterms:W3CDTF">2019-01-04T16:06:32Z</dcterms:created>
  <dcterms:modified xsi:type="dcterms:W3CDTF">2023-06-01T16:36:14Z</dcterms:modified>
</cp:coreProperties>
</file>